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064" autoAdjust="0"/>
  </p:normalViewPr>
  <p:slideViewPr>
    <p:cSldViewPr snapToGrid="0" snapToObjects="1">
      <p:cViewPr>
        <p:scale>
          <a:sx n="254" d="100"/>
          <a:sy n="254" d="100"/>
        </p:scale>
        <p:origin x="3232" y="1004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%20Macintosh:Users:apple:Google%20Drive:work:SNP:snp.tabl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6022965879265"/>
          <c:y val="0.0284196069180484"/>
          <c:w val="0.84494372655273"/>
          <c:h val="0.8618054655528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Ts-Tv'!$B$9</c:f>
              <c:strCache>
                <c:ptCount val="1"/>
                <c:pt idx="0">
                  <c:v>Transitions</c:v>
                </c:pt>
              </c:strCache>
            </c:strRef>
          </c:tx>
          <c:invertIfNegative val="0"/>
          <c:dLbls>
            <c:txPr>
              <a:bodyPr rot="-5400000" vert="horz" anchor="ctr" anchorCtr="1"/>
              <a:lstStyle/>
              <a:p>
                <a:pPr>
                  <a:defRPr/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'Ts-Tv'!$A$10:$A$12</c:f>
              <c:strCache>
                <c:ptCount val="3"/>
                <c:pt idx="0">
                  <c:v>Ml/Ms</c:v>
                </c:pt>
                <c:pt idx="1">
                  <c:v>Ml/Mn</c:v>
                </c:pt>
                <c:pt idx="2">
                  <c:v>Ms/Mn</c:v>
                </c:pt>
              </c:strCache>
            </c:strRef>
          </c:cat>
          <c:val>
            <c:numRef>
              <c:f>'Ts-Tv'!$B$10:$B$12</c:f>
              <c:numCache>
                <c:formatCode>General</c:formatCode>
                <c:ptCount val="3"/>
                <c:pt idx="0">
                  <c:v>110542.0</c:v>
                </c:pt>
                <c:pt idx="1">
                  <c:v>321008.0</c:v>
                </c:pt>
                <c:pt idx="2">
                  <c:v>322221.0</c:v>
                </c:pt>
              </c:numCache>
            </c:numRef>
          </c:val>
        </c:ser>
        <c:ser>
          <c:idx val="1"/>
          <c:order val="1"/>
          <c:tx>
            <c:strRef>
              <c:f>'Ts-Tv'!$C$9</c:f>
              <c:strCache>
                <c:ptCount val="1"/>
                <c:pt idx="0">
                  <c:v>Transversions</c:v>
                </c:pt>
              </c:strCache>
            </c:strRef>
          </c:tx>
          <c:invertIfNegative val="0"/>
          <c:dLbls>
            <c:txPr>
              <a:bodyPr rot="-5400000" vert="horz"/>
              <a:lstStyle/>
              <a:p>
                <a:pPr>
                  <a:defRPr/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'Ts-Tv'!$A$10:$A$12</c:f>
              <c:strCache>
                <c:ptCount val="3"/>
                <c:pt idx="0">
                  <c:v>Ml/Ms</c:v>
                </c:pt>
                <c:pt idx="1">
                  <c:v>Ml/Mn</c:v>
                </c:pt>
                <c:pt idx="2">
                  <c:v>Ms/Mn</c:v>
                </c:pt>
              </c:strCache>
            </c:strRef>
          </c:cat>
          <c:val>
            <c:numRef>
              <c:f>'Ts-Tv'!$C$10:$C$12</c:f>
              <c:numCache>
                <c:formatCode>General</c:formatCode>
                <c:ptCount val="3"/>
                <c:pt idx="0">
                  <c:v>63826.0</c:v>
                </c:pt>
                <c:pt idx="1">
                  <c:v>191237.0</c:v>
                </c:pt>
                <c:pt idx="2">
                  <c:v>192492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8260776"/>
        <c:axId val="2077231592"/>
      </c:barChart>
      <c:catAx>
        <c:axId val="2078260776"/>
        <c:scaling>
          <c:orientation val="minMax"/>
        </c:scaling>
        <c:delete val="0"/>
        <c:axPos val="b"/>
        <c:majorTickMark val="out"/>
        <c:minorTickMark val="none"/>
        <c:tickLblPos val="nextTo"/>
        <c:crossAx val="2077231592"/>
        <c:crosses val="autoZero"/>
        <c:auto val="1"/>
        <c:lblAlgn val="ctr"/>
        <c:lblOffset val="100"/>
        <c:noMultiLvlLbl val="0"/>
      </c:catAx>
      <c:valAx>
        <c:axId val="20772315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078260776"/>
        <c:crosses val="autoZero"/>
        <c:crossBetween val="between"/>
      </c:valAx>
      <c:spPr>
        <a:solidFill>
          <a:schemeClr val="bg1">
            <a:lumMod val="95000"/>
          </a:schemeClr>
        </a:solidFill>
        <a:ln>
          <a:noFill/>
        </a:ln>
      </c:spPr>
    </c:plotArea>
    <c:legend>
      <c:legendPos val="r"/>
      <c:layout>
        <c:manualLayout>
          <c:xMode val="edge"/>
          <c:yMode val="edge"/>
          <c:x val="0.134791119860017"/>
          <c:y val="0.00901246719160107"/>
          <c:w val="0.845764435695538"/>
          <c:h val="0.0699380285797608"/>
        </c:manualLayout>
      </c:layout>
      <c:overlay val="0"/>
    </c:legend>
    <c:plotVisOnly val="1"/>
    <c:dispBlanksAs val="gap"/>
    <c:showDLblsOverMax val="0"/>
  </c:chart>
  <c:spPr>
    <a:ln>
      <a:solidFill>
        <a:srgbClr val="7F7F7F"/>
      </a:solidFill>
    </a:ln>
  </c:spPr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369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8789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8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698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72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126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52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8" y="3081868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3" y="3081868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9336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5663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621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791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94407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735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783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3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130253-22B7-7D40-86AB-5AB303E2C5C4}" type="datetimeFigureOut">
              <a:rPr lang="en-US" smtClean="0"/>
              <a:t>27/10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428D90-328F-8F4C-A0D7-3E87A72B36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611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3744480"/>
              </p:ext>
            </p:extLst>
          </p:nvPr>
        </p:nvGraphicFramePr>
        <p:xfrm>
          <a:off x="1619713" y="4959862"/>
          <a:ext cx="3598500" cy="923575"/>
        </p:xfrm>
        <a:graphic>
          <a:graphicData uri="http://schemas.openxmlformats.org/drawingml/2006/table">
            <a:tbl>
              <a:tblPr/>
              <a:tblGrid>
                <a:gridCol w="719700"/>
                <a:gridCol w="719700"/>
                <a:gridCol w="719700"/>
                <a:gridCol w="719700"/>
                <a:gridCol w="719700"/>
              </a:tblGrid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l/</a:t>
                      </a:r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</a:t>
                      </a: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3,891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1,222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B3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6,363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</a:tr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</a:t>
                      </a: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,71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,512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9,341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B3D7"/>
                    </a:solidFill>
                  </a:tcPr>
                </a:tc>
              </a:tr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</a:t>
                      </a: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8,842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B3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,596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,90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</a:tr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</a:t>
                      </a: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6,577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1,603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5B3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3,688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663628"/>
              </p:ext>
            </p:extLst>
          </p:nvPr>
        </p:nvGraphicFramePr>
        <p:xfrm>
          <a:off x="1619713" y="3986007"/>
          <a:ext cx="3598500" cy="923575"/>
        </p:xfrm>
        <a:graphic>
          <a:graphicData uri="http://schemas.openxmlformats.org/drawingml/2006/table">
            <a:tbl>
              <a:tblPr/>
              <a:tblGrid>
                <a:gridCol w="719700"/>
                <a:gridCol w="719700"/>
                <a:gridCol w="719700"/>
                <a:gridCol w="719700"/>
                <a:gridCol w="719700"/>
              </a:tblGrid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l/</a:t>
                      </a:r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</a:t>
                      </a: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,875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7,81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B3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,923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</a:tr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</a:t>
                      </a: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,909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,362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7,35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B3D7"/>
                    </a:solidFill>
                  </a:tcPr>
                </a:tc>
              </a:tr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</a:t>
                      </a: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7,52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B3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,353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,818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</a:tr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</a:t>
                      </a: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,836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7,862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5B3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,75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83294502"/>
              </p:ext>
            </p:extLst>
          </p:nvPr>
        </p:nvGraphicFramePr>
        <p:xfrm>
          <a:off x="1619713" y="5932316"/>
          <a:ext cx="3598500" cy="923575"/>
        </p:xfrm>
        <a:graphic>
          <a:graphicData uri="http://schemas.openxmlformats.org/drawingml/2006/table">
            <a:tbl>
              <a:tblPr/>
              <a:tblGrid>
                <a:gridCol w="719700"/>
                <a:gridCol w="719700"/>
                <a:gridCol w="719700"/>
                <a:gridCol w="719700"/>
                <a:gridCol w="719700"/>
              </a:tblGrid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s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/</a:t>
                      </a:r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n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</a:tr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</a:t>
                      </a: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4,259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2,227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5B3D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6,382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</a:tr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</a:t>
                      </a: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,839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,917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8,45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8CCE4"/>
                    </a:solidFill>
                  </a:tcPr>
                </a:tc>
              </a:tr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</a:t>
                      </a: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8,663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8C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,514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,881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CE6F1"/>
                    </a:solidFill>
                  </a:tcPr>
                </a:tc>
              </a:tr>
              <a:tr h="1847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</a:t>
                      </a:r>
                    </a:p>
                  </a:txBody>
                  <a:tcPr marL="12700" marR="12700" marT="13758" marB="0" anchor="b">
                    <a:lnL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6,521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2,881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C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4,179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CE6F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</a:t>
                      </a:r>
                    </a:p>
                  </a:txBody>
                  <a:tcPr marL="12700" marR="12700" marT="13758" marB="0" anchor="b">
                    <a:lnL>
                      <a:noFill/>
                    </a:lnL>
                    <a:lnR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80808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2682859" y="6967170"/>
            <a:ext cx="25451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dirty="0" smtClean="0">
                <a:latin typeface="Arial"/>
                <a:cs typeface="Arial"/>
              </a:rPr>
              <a:t>Supporting </a:t>
            </a:r>
            <a:r>
              <a:rPr lang="en-US" sz="1000" smtClean="0">
                <a:latin typeface="Arial"/>
                <a:cs typeface="Arial"/>
              </a:rPr>
              <a:t>Figure </a:t>
            </a:r>
            <a:r>
              <a:rPr lang="en-US" sz="1000" smtClean="0">
                <a:latin typeface="Arial"/>
                <a:cs typeface="Arial"/>
              </a:rPr>
              <a:t>3.</a:t>
            </a:r>
            <a:endParaRPr lang="en-US" sz="1000" dirty="0">
              <a:latin typeface="Arial"/>
              <a:cs typeface="Arial"/>
            </a:endParaRPr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3835241"/>
              </p:ext>
            </p:extLst>
          </p:nvPr>
        </p:nvGraphicFramePr>
        <p:xfrm>
          <a:off x="1619713" y="1783850"/>
          <a:ext cx="3598500" cy="21449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1319631" y="1783850"/>
            <a:ext cx="300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953735"/>
                </a:solidFill>
                <a:latin typeface="Arial"/>
                <a:cs typeface="Arial"/>
              </a:rPr>
              <a:t>A</a:t>
            </a:r>
            <a:endParaRPr lang="en-US" sz="1400" dirty="0">
              <a:solidFill>
                <a:srgbClr val="953735"/>
              </a:solidFill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314491" y="3982926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rgbClr val="953735"/>
                </a:solidFill>
                <a:latin typeface="Arial"/>
                <a:cs typeface="Arial"/>
              </a:rPr>
              <a:t>B</a:t>
            </a:r>
            <a:endParaRPr lang="en-US" sz="1400" dirty="0">
              <a:solidFill>
                <a:srgbClr val="953735"/>
              </a:solidFill>
              <a:latin typeface="Arial"/>
              <a:cs typeface="Arial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54000" y="4540250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04945393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87</Words>
  <Application>Microsoft Macintosh PowerPoint</Application>
  <PresentationFormat>A4 Paper (210x297 mm)</PresentationFormat>
  <Paragraphs>7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ushra</dc:creator>
  <cp:lastModifiedBy>Bushra</cp:lastModifiedBy>
  <cp:revision>11</cp:revision>
  <dcterms:created xsi:type="dcterms:W3CDTF">2015-07-06T15:19:10Z</dcterms:created>
  <dcterms:modified xsi:type="dcterms:W3CDTF">2015-10-27T15:41:17Z</dcterms:modified>
</cp:coreProperties>
</file>